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9" r:id="rId2"/>
  </p:sldIdLst>
  <p:sldSz cx="9144000" cy="6858000" type="screen4x3"/>
  <p:notesSz cx="7010400" cy="92233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zan, Heba Fathy" initials="AHF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745" autoAdjust="0"/>
    <p:restoredTop sz="94512" autoAdjust="0"/>
  </p:normalViewPr>
  <p:slideViewPr>
    <p:cSldViewPr>
      <p:cViewPr varScale="1">
        <p:scale>
          <a:sx n="74" d="100"/>
          <a:sy n="74" d="100"/>
        </p:scale>
        <p:origin x="1134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ebaalzan\Desktop\recombinant%20prtoein%20vaccination\results\Ab%20in%20hemolymph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hebaalzan\Desktop\recombinant%20prtoein%20vaccination\results\Ab%20in%20hemolymph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450'!$B$11</c:f>
              <c:strCache>
                <c:ptCount val="1"/>
                <c:pt idx="0">
                  <c:v>OD values 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numRef>
              <c:f>'450'!$C$10:$V$10</c:f>
              <c:numCache>
                <c:formatCode>General</c:formatCode>
                <c:ptCount val="20"/>
                <c:pt idx="0">
                  <c:v>1502</c:v>
                </c:pt>
                <c:pt idx="1">
                  <c:v>1505</c:v>
                </c:pt>
                <c:pt idx="2">
                  <c:v>1512</c:v>
                </c:pt>
                <c:pt idx="3">
                  <c:v>1501</c:v>
                </c:pt>
                <c:pt idx="4">
                  <c:v>1506</c:v>
                </c:pt>
                <c:pt idx="5">
                  <c:v>1508</c:v>
                </c:pt>
                <c:pt idx="7">
                  <c:v>1502</c:v>
                </c:pt>
                <c:pt idx="8">
                  <c:v>1505</c:v>
                </c:pt>
                <c:pt idx="9">
                  <c:v>1512</c:v>
                </c:pt>
                <c:pt idx="10">
                  <c:v>1501</c:v>
                </c:pt>
                <c:pt idx="11">
                  <c:v>1506</c:v>
                </c:pt>
                <c:pt idx="12">
                  <c:v>1508</c:v>
                </c:pt>
                <c:pt idx="14">
                  <c:v>1502</c:v>
                </c:pt>
                <c:pt idx="15">
                  <c:v>1505</c:v>
                </c:pt>
                <c:pt idx="16">
                  <c:v>1512</c:v>
                </c:pt>
                <c:pt idx="17">
                  <c:v>1501</c:v>
                </c:pt>
                <c:pt idx="18">
                  <c:v>1506</c:v>
                </c:pt>
                <c:pt idx="19">
                  <c:v>1508</c:v>
                </c:pt>
              </c:numCache>
            </c:numRef>
          </c:cat>
          <c:val>
            <c:numRef>
              <c:f>'450'!$C$11:$V$11</c:f>
              <c:numCache>
                <c:formatCode>General</c:formatCode>
                <c:ptCount val="20"/>
                <c:pt idx="0">
                  <c:v>0.1061</c:v>
                </c:pt>
                <c:pt idx="1">
                  <c:v>8.2350000000000007E-2</c:v>
                </c:pt>
                <c:pt idx="2">
                  <c:v>8.6849999999999997E-2</c:v>
                </c:pt>
                <c:pt idx="3">
                  <c:v>0.3861</c:v>
                </c:pt>
                <c:pt idx="4">
                  <c:v>0.49825000000000003</c:v>
                </c:pt>
                <c:pt idx="5">
                  <c:v>0.55535000000000001</c:v>
                </c:pt>
                <c:pt idx="7">
                  <c:v>9.2249999999999999E-2</c:v>
                </c:pt>
                <c:pt idx="8">
                  <c:v>9.1799999999999993E-2</c:v>
                </c:pt>
                <c:pt idx="9">
                  <c:v>8.7249999999999994E-2</c:v>
                </c:pt>
                <c:pt idx="10">
                  <c:v>0.29490000000000005</c:v>
                </c:pt>
                <c:pt idx="11">
                  <c:v>0.41985</c:v>
                </c:pt>
                <c:pt idx="12">
                  <c:v>0.43815000000000004</c:v>
                </c:pt>
                <c:pt idx="14">
                  <c:v>9.2499999999999999E-2</c:v>
                </c:pt>
                <c:pt idx="15">
                  <c:v>0.10059999999999999</c:v>
                </c:pt>
                <c:pt idx="16">
                  <c:v>0.10845</c:v>
                </c:pt>
                <c:pt idx="17">
                  <c:v>0.24645</c:v>
                </c:pt>
                <c:pt idx="18">
                  <c:v>0.59194999999999998</c:v>
                </c:pt>
                <c:pt idx="19">
                  <c:v>0.2936499999999999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821-AB44-9A23-21580DA7F8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28538496"/>
        <c:axId val="132722672"/>
      </c:barChart>
      <c:catAx>
        <c:axId val="3285384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32722672"/>
        <c:crosses val="autoZero"/>
        <c:auto val="1"/>
        <c:lblAlgn val="ctr"/>
        <c:lblOffset val="100"/>
        <c:noMultiLvlLbl val="0"/>
      </c:catAx>
      <c:valAx>
        <c:axId val="132722672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D Values</a:t>
                </a:r>
              </a:p>
            </c:rich>
          </c:tx>
          <c:layout>
            <c:manualLayout>
              <c:xMode val="edge"/>
              <c:yMode val="edge"/>
              <c:x val="8.3542649952261117E-3"/>
              <c:y val="0.16216978424448131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32853849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4!$A$6</c:f>
              <c:strCache>
                <c:ptCount val="1"/>
                <c:pt idx="0">
                  <c:v>OD values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Sheet4!$B$4:$U$5</c:f>
              <c:multiLvlStrCache>
                <c:ptCount val="20"/>
                <c:lvl>
                  <c:pt idx="0">
                    <c:v>IgG1</c:v>
                  </c:pt>
                  <c:pt idx="1">
                    <c:v>IgG2</c:v>
                  </c:pt>
                  <c:pt idx="2">
                    <c:v>IgG1</c:v>
                  </c:pt>
                  <c:pt idx="3">
                    <c:v>IgG2</c:v>
                  </c:pt>
                  <c:pt idx="4">
                    <c:v>IgG1</c:v>
                  </c:pt>
                  <c:pt idx="5">
                    <c:v>IgG2</c:v>
                  </c:pt>
                  <c:pt idx="7">
                    <c:v>IgG1</c:v>
                  </c:pt>
                  <c:pt idx="8">
                    <c:v>IgG2</c:v>
                  </c:pt>
                  <c:pt idx="9">
                    <c:v>IgG1</c:v>
                  </c:pt>
                  <c:pt idx="10">
                    <c:v>IgG2</c:v>
                  </c:pt>
                  <c:pt idx="11">
                    <c:v>IgG1</c:v>
                  </c:pt>
                  <c:pt idx="12">
                    <c:v>IgG2</c:v>
                  </c:pt>
                  <c:pt idx="14">
                    <c:v>IgG1</c:v>
                  </c:pt>
                  <c:pt idx="15">
                    <c:v>IgG2</c:v>
                  </c:pt>
                  <c:pt idx="16">
                    <c:v>IgG1</c:v>
                  </c:pt>
                  <c:pt idx="17">
                    <c:v>IgG2</c:v>
                  </c:pt>
                  <c:pt idx="18">
                    <c:v>IgG1</c:v>
                  </c:pt>
                  <c:pt idx="19">
                    <c:v>IgG2</c:v>
                  </c:pt>
                </c:lvl>
                <c:lvl>
                  <c:pt idx="0">
                    <c:v>1501</c:v>
                  </c:pt>
                  <c:pt idx="2">
                    <c:v>1506</c:v>
                  </c:pt>
                  <c:pt idx="4">
                    <c:v>1508</c:v>
                  </c:pt>
                  <c:pt idx="7">
                    <c:v>1501</c:v>
                  </c:pt>
                  <c:pt idx="9">
                    <c:v>1506</c:v>
                  </c:pt>
                  <c:pt idx="11">
                    <c:v>1508</c:v>
                  </c:pt>
                  <c:pt idx="14">
                    <c:v>1501</c:v>
                  </c:pt>
                  <c:pt idx="16">
                    <c:v>1506</c:v>
                  </c:pt>
                  <c:pt idx="18">
                    <c:v>1508</c:v>
                  </c:pt>
                </c:lvl>
              </c:multiLvlStrCache>
            </c:multiLvlStrRef>
          </c:cat>
          <c:val>
            <c:numRef>
              <c:f>Sheet4!$B$6:$U$6</c:f>
              <c:numCache>
                <c:formatCode>General</c:formatCode>
                <c:ptCount val="20"/>
                <c:pt idx="0">
                  <c:v>0.16159999999999999</c:v>
                </c:pt>
                <c:pt idx="1">
                  <c:v>0.29380000000000001</c:v>
                </c:pt>
                <c:pt idx="2">
                  <c:v>0.1915</c:v>
                </c:pt>
                <c:pt idx="3">
                  <c:v>0.43059999999999998</c:v>
                </c:pt>
                <c:pt idx="4">
                  <c:v>0.1966</c:v>
                </c:pt>
                <c:pt idx="5">
                  <c:v>0.66569999999999996</c:v>
                </c:pt>
                <c:pt idx="7">
                  <c:v>0.1186</c:v>
                </c:pt>
                <c:pt idx="8">
                  <c:v>0.20469999999999999</c:v>
                </c:pt>
                <c:pt idx="9">
                  <c:v>0.1462</c:v>
                </c:pt>
                <c:pt idx="10">
                  <c:v>0.32279999999999998</c:v>
                </c:pt>
                <c:pt idx="11">
                  <c:v>0.12659999999999999</c:v>
                </c:pt>
                <c:pt idx="12">
                  <c:v>0.48780000000000001</c:v>
                </c:pt>
                <c:pt idx="14">
                  <c:v>0.1421</c:v>
                </c:pt>
                <c:pt idx="15">
                  <c:v>0.2374</c:v>
                </c:pt>
                <c:pt idx="16">
                  <c:v>0.18920000000000001</c:v>
                </c:pt>
                <c:pt idx="17">
                  <c:v>0.48230000000000001</c:v>
                </c:pt>
                <c:pt idx="18">
                  <c:v>0.15840000000000001</c:v>
                </c:pt>
                <c:pt idx="19">
                  <c:v>0.59360000000000002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F929-6944-8D35-F9FD4FE146D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03633568"/>
        <c:axId val="403629216"/>
      </c:barChart>
      <c:catAx>
        <c:axId val="403633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3629216"/>
        <c:crosses val="autoZero"/>
        <c:auto val="1"/>
        <c:lblAlgn val="ctr"/>
        <c:lblOffset val="100"/>
        <c:noMultiLvlLbl val="0"/>
      </c:catAx>
      <c:valAx>
        <c:axId val="40362921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OD Values </a:t>
                </a:r>
              </a:p>
            </c:rich>
          </c:tx>
          <c:layout>
            <c:manualLayout>
              <c:xMode val="edge"/>
              <c:yMode val="edge"/>
              <c:x val="0"/>
              <c:y val="0.18143196255524999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40363356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2FA3D-2F7A-4AA2-95AC-80D01F2A9AF3}" type="datetimeFigureOut">
              <a:rPr lang="en-US" smtClean="0"/>
              <a:t>4/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1103"/>
            <a:ext cx="5608320" cy="415051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734BAE-C534-479E-A9FC-EAFBA29B5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936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8: Bovine 6 </a:t>
            </a:r>
            <a:r>
              <a:rPr lang="en-US" dirty="0" err="1"/>
              <a:t>cys</a:t>
            </a:r>
            <a:r>
              <a:rPr lang="en-US" dirty="0"/>
              <a:t> antibodies detection in tick hemolymph against 6cys A recombinant protein by ELISA . Upper chart: illustrate the presence of bovine 6cys antibodies in the 1</a:t>
            </a:r>
            <a:r>
              <a:rPr lang="en-US" baseline="30000" dirty="0"/>
              <a:t>st</a:t>
            </a:r>
            <a:r>
              <a:rPr lang="en-US" dirty="0"/>
              <a:t> and 2</a:t>
            </a:r>
            <a:r>
              <a:rPr lang="en-US" baseline="30000" dirty="0"/>
              <a:t>nd</a:t>
            </a:r>
            <a:r>
              <a:rPr lang="en-US" dirty="0"/>
              <a:t> tick hemolymph groups from vaccinated animals vs ticks hemolymph from non vaccinated animals in comparison with the bovine serum from both animals group. The bottom chart: illustration of the antibodies isotyping of the passed bovine 6 </a:t>
            </a:r>
            <a:r>
              <a:rPr lang="en-US" dirty="0" err="1"/>
              <a:t>cys</a:t>
            </a:r>
            <a:r>
              <a:rPr lang="en-US" dirty="0"/>
              <a:t> antibodies to the tick hemolymph 1</a:t>
            </a:r>
            <a:r>
              <a:rPr lang="en-US" baseline="30000" dirty="0"/>
              <a:t>st</a:t>
            </a:r>
            <a:r>
              <a:rPr lang="en-US" dirty="0"/>
              <a:t> and 2</a:t>
            </a:r>
            <a:r>
              <a:rPr lang="en-US" baseline="30000" dirty="0"/>
              <a:t>nd</a:t>
            </a:r>
            <a:r>
              <a:rPr lang="en-US" dirty="0"/>
              <a:t> groups from vaccinated animal group in comparison with the animals serum. IgGs2 were  more prevalent than IgGs1 in the tick hemolymph   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3734BAE-C534-479E-A9FC-EAFBA29B50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6417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>
            <a:extLst>
              <a:ext uri="{FF2B5EF4-FFF2-40B4-BE49-F238E27FC236}">
                <a16:creationId xmlns:a16="http://schemas.microsoft.com/office/drawing/2014/main" xmlns="" id="{657BD29C-AC9E-4642-AE66-9E9363C4720B}"/>
              </a:ext>
            </a:extLst>
          </p:cNvPr>
          <p:cNvGrpSpPr/>
          <p:nvPr/>
        </p:nvGrpSpPr>
        <p:grpSpPr>
          <a:xfrm>
            <a:off x="533400" y="457200"/>
            <a:ext cx="8581493" cy="6655245"/>
            <a:chOff x="533400" y="457200"/>
            <a:chExt cx="8581493" cy="6655245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xmlns="" id="{FF231A21-9AD1-F44F-859B-7B132C9C5BEB}"/>
                </a:ext>
              </a:extLst>
            </p:cNvPr>
            <p:cNvGrpSpPr/>
            <p:nvPr/>
          </p:nvGrpSpPr>
          <p:grpSpPr>
            <a:xfrm>
              <a:off x="533400" y="457200"/>
              <a:ext cx="7153275" cy="4648200"/>
              <a:chOff x="533400" y="457200"/>
              <a:chExt cx="7153275" cy="4648200"/>
            </a:xfrm>
          </p:grpSpPr>
          <p:graphicFrame>
            <p:nvGraphicFramePr>
              <p:cNvPr id="3" name="Chart 2">
                <a:extLst>
                  <a:ext uri="{FF2B5EF4-FFF2-40B4-BE49-F238E27FC236}">
                    <a16:creationId xmlns:a16="http://schemas.microsoft.com/office/drawing/2014/main" xmlns="" id="{9D678F9F-E7DE-6E4D-B581-3BEF48465298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582329121"/>
                  </p:ext>
                </p:extLst>
              </p:nvPr>
            </p:nvGraphicFramePr>
            <p:xfrm>
              <a:off x="1219200" y="457200"/>
              <a:ext cx="6467475" cy="20034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4" name="Rectangle 3">
                <a:extLst>
                  <a:ext uri="{FF2B5EF4-FFF2-40B4-BE49-F238E27FC236}">
                    <a16:creationId xmlns:a16="http://schemas.microsoft.com/office/drawing/2014/main" xmlns="" id="{57C6B2C7-911A-C34B-9C8E-F6A30D3D7F6E}"/>
                  </a:ext>
                </a:extLst>
              </p:cNvPr>
              <p:cNvSpPr/>
              <p:nvPr/>
            </p:nvSpPr>
            <p:spPr>
              <a:xfrm>
                <a:off x="1752600" y="2384425"/>
                <a:ext cx="1676400" cy="511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nimal serum </a:t>
                </a:r>
              </a:p>
            </p:txBody>
          </p:sp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xmlns="" id="{76CE07E4-B6BC-684B-874C-3562EE3EAB29}"/>
                  </a:ext>
                </a:extLst>
              </p:cNvPr>
              <p:cNvSpPr/>
              <p:nvPr/>
            </p:nvSpPr>
            <p:spPr>
              <a:xfrm>
                <a:off x="3733800" y="2460625"/>
                <a:ext cx="1676400" cy="511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ck Hemolymph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  <a:r>
                  <a:rPr lang="en-US" sz="12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t</a:t>
                </a:r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group  </a:t>
                </a:r>
              </a:p>
            </p:txBody>
          </p:sp>
          <p:sp>
            <p:nvSpPr>
              <p:cNvPr id="6" name="Rectangle 5">
                <a:extLst>
                  <a:ext uri="{FF2B5EF4-FFF2-40B4-BE49-F238E27FC236}">
                    <a16:creationId xmlns:a16="http://schemas.microsoft.com/office/drawing/2014/main" xmlns="" id="{1371EB13-CB4E-C441-8274-DE5B3616CF9F}"/>
                  </a:ext>
                </a:extLst>
              </p:cNvPr>
              <p:cNvSpPr/>
              <p:nvPr/>
            </p:nvSpPr>
            <p:spPr>
              <a:xfrm>
                <a:off x="5638800" y="2460625"/>
                <a:ext cx="1676400" cy="511175"/>
              </a:xfrm>
              <a:prstGeom prst="rect">
                <a:avLst/>
              </a:prstGeom>
              <a:noFill/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ick Hemolymph</a:t>
                </a:r>
              </a:p>
              <a:p>
                <a:pPr algn="ctr"/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1200" baseline="300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nd</a:t>
                </a:r>
                <a:r>
                  <a:rPr lang="en-US" sz="1200" dirty="0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group  </a:t>
                </a:r>
              </a:p>
            </p:txBody>
          </p:sp>
          <p:graphicFrame>
            <p:nvGraphicFramePr>
              <p:cNvPr id="7" name="Chart 6">
                <a:extLst>
                  <a:ext uri="{FF2B5EF4-FFF2-40B4-BE49-F238E27FC236}">
                    <a16:creationId xmlns:a16="http://schemas.microsoft.com/office/drawing/2014/main" xmlns="" id="{A2743F7F-17D3-0D46-B8AF-85451ECADBE4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13387603"/>
                  </p:ext>
                </p:extLst>
              </p:nvPr>
            </p:nvGraphicFramePr>
            <p:xfrm>
              <a:off x="1219200" y="2751136"/>
              <a:ext cx="6248400" cy="235426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533400" y="545068"/>
                <a:ext cx="28886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/>
                  <a:t>A</a:t>
                </a: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533400" y="2907268"/>
                <a:ext cx="304892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xmlns="" id="{81E2804F-B717-7343-8749-20555EE28170}"/>
                </a:ext>
              </a:extLst>
            </p:cNvPr>
            <p:cNvGrpSpPr/>
            <p:nvPr/>
          </p:nvGrpSpPr>
          <p:grpSpPr>
            <a:xfrm>
              <a:off x="1676708" y="2215574"/>
              <a:ext cx="7438185" cy="4896871"/>
              <a:chOff x="1676708" y="2215574"/>
              <a:chExt cx="7438185" cy="4896871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xmlns="" id="{5623FE4C-0A75-8541-9113-0AC296BECECA}"/>
                  </a:ext>
                </a:extLst>
              </p:cNvPr>
              <p:cNvSpPr txBox="1"/>
              <p:nvPr/>
            </p:nvSpPr>
            <p:spPr>
              <a:xfrm>
                <a:off x="8382000" y="6466114"/>
                <a:ext cx="732893" cy="64633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/>
                  <a:t>Fig.S7</a:t>
                </a:r>
              </a:p>
              <a:p>
                <a:endParaRPr lang="en-US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xmlns="" id="{7C8C6F97-34E2-2E43-B4EA-A9FCD3BF1E1A}"/>
                  </a:ext>
                </a:extLst>
              </p:cNvPr>
              <p:cNvSpPr txBox="1"/>
              <p:nvPr/>
            </p:nvSpPr>
            <p:spPr>
              <a:xfrm>
                <a:off x="1883138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xmlns="" id="{462C6B9B-F18A-D94E-A09B-9637A769F896}"/>
                  </a:ext>
                </a:extLst>
              </p:cNvPr>
              <p:cNvSpPr txBox="1"/>
              <p:nvPr/>
            </p:nvSpPr>
            <p:spPr>
              <a:xfrm>
                <a:off x="2416538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xmlns="" id="{834100D1-5267-A142-A8D4-72F73560AAAA}"/>
                  </a:ext>
                </a:extLst>
              </p:cNvPr>
              <p:cNvSpPr txBox="1"/>
              <p:nvPr/>
            </p:nvSpPr>
            <p:spPr>
              <a:xfrm>
                <a:off x="3076388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xmlns="" id="{114F30BA-2BB4-4D46-B7E7-00BE07764312}"/>
                  </a:ext>
                </a:extLst>
              </p:cNvPr>
              <p:cNvSpPr txBox="1"/>
              <p:nvPr/>
            </p:nvSpPr>
            <p:spPr>
              <a:xfrm>
                <a:off x="3750038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xmlns="" id="{0EA9CC9B-B3A1-D44B-B894-CA8C06DDE898}"/>
                  </a:ext>
                </a:extLst>
              </p:cNvPr>
              <p:cNvSpPr txBox="1"/>
              <p:nvPr/>
            </p:nvSpPr>
            <p:spPr>
              <a:xfrm>
                <a:off x="4302176" y="482610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xmlns="" id="{9C29FB81-D9C3-D54E-AE46-CB141D614E3B}"/>
                  </a:ext>
                </a:extLst>
              </p:cNvPr>
              <p:cNvSpPr txBox="1"/>
              <p:nvPr/>
            </p:nvSpPr>
            <p:spPr>
              <a:xfrm>
                <a:off x="4966454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xmlns="" id="{B7BFACAD-371A-6348-BA6F-BFC39CCBCA55}"/>
                  </a:ext>
                </a:extLst>
              </p:cNvPr>
              <p:cNvSpPr txBox="1"/>
              <p:nvPr/>
            </p:nvSpPr>
            <p:spPr>
              <a:xfrm>
                <a:off x="5654414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xmlns="" id="{78A0C041-CE5D-414A-B0DC-9CD2AB101208}"/>
                  </a:ext>
                </a:extLst>
              </p:cNvPr>
              <p:cNvSpPr txBox="1"/>
              <p:nvPr/>
            </p:nvSpPr>
            <p:spPr>
              <a:xfrm>
                <a:off x="6183926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xmlns="" id="{4F1698C4-813D-544B-83F2-83EB1FAF4B0B}"/>
                  </a:ext>
                </a:extLst>
              </p:cNvPr>
              <p:cNvSpPr txBox="1"/>
              <p:nvPr/>
            </p:nvSpPr>
            <p:spPr>
              <a:xfrm>
                <a:off x="6728330" y="4822825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xmlns="" id="{ACAEDDDF-DF41-3347-9C74-CEAAE66E51DD}"/>
                  </a:ext>
                </a:extLst>
              </p:cNvPr>
              <p:cNvSpPr txBox="1"/>
              <p:nvPr/>
            </p:nvSpPr>
            <p:spPr>
              <a:xfrm rot="18614811">
                <a:off x="16932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xmlns="" id="{E3A30693-BE51-754A-9F18-DA6E9E7D7C7D}"/>
                  </a:ext>
                </a:extLst>
              </p:cNvPr>
              <p:cNvSpPr txBox="1"/>
              <p:nvPr/>
            </p:nvSpPr>
            <p:spPr>
              <a:xfrm rot="18614811">
                <a:off x="1964386" y="2217394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xmlns="" id="{6FA20D77-31BC-1347-9F98-7F72B0F468CA}"/>
                  </a:ext>
                </a:extLst>
              </p:cNvPr>
              <p:cNvSpPr txBox="1"/>
              <p:nvPr/>
            </p:nvSpPr>
            <p:spPr>
              <a:xfrm rot="18614811">
                <a:off x="22266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xmlns="" id="{3CDFDCDB-E30E-7140-B1BF-40744689FD87}"/>
                  </a:ext>
                </a:extLst>
              </p:cNvPr>
              <p:cNvSpPr txBox="1"/>
              <p:nvPr/>
            </p:nvSpPr>
            <p:spPr>
              <a:xfrm rot="18614811">
                <a:off x="2531410" y="2212044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xmlns="" id="{E059BBA7-E617-B74F-BF50-BD9D46BD6052}"/>
                  </a:ext>
                </a:extLst>
              </p:cNvPr>
              <p:cNvSpPr txBox="1"/>
              <p:nvPr/>
            </p:nvSpPr>
            <p:spPr>
              <a:xfrm rot="18614811">
                <a:off x="279613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xmlns="" id="{0F8475EC-2982-5C4F-B625-E18B9E5855DF}"/>
                  </a:ext>
                </a:extLst>
              </p:cNvPr>
              <p:cNvSpPr txBox="1"/>
              <p:nvPr/>
            </p:nvSpPr>
            <p:spPr>
              <a:xfrm rot="18614811">
                <a:off x="3107387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xmlns="" id="{3A9806B8-6B60-2741-83E8-EE7F9C8BC279}"/>
                  </a:ext>
                </a:extLst>
              </p:cNvPr>
              <p:cNvSpPr txBox="1"/>
              <p:nvPr/>
            </p:nvSpPr>
            <p:spPr>
              <a:xfrm rot="18614811">
                <a:off x="3640787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xmlns="" id="{2BB1D7DB-77E7-4749-A5AC-3A7175959647}"/>
                  </a:ext>
                </a:extLst>
              </p:cNvPr>
              <p:cNvSpPr txBox="1"/>
              <p:nvPr/>
            </p:nvSpPr>
            <p:spPr>
              <a:xfrm rot="18614811">
                <a:off x="3931877" y="222578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xmlns="" id="{83654CFF-714B-5941-AF4A-2FBA92D47241}"/>
                  </a:ext>
                </a:extLst>
              </p:cNvPr>
              <p:cNvSpPr txBox="1"/>
              <p:nvPr/>
            </p:nvSpPr>
            <p:spPr>
              <a:xfrm rot="18614811">
                <a:off x="4209738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xmlns="" id="{AB1973E4-EA8C-DB4F-B453-F6871452F6DC}"/>
                  </a:ext>
                </a:extLst>
              </p:cNvPr>
              <p:cNvSpPr txBox="1"/>
              <p:nvPr/>
            </p:nvSpPr>
            <p:spPr>
              <a:xfrm rot="18614811">
                <a:off x="45126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xmlns="" id="{EF15AD2A-094B-5543-BD2F-FA44C3739DAE}"/>
                  </a:ext>
                </a:extLst>
              </p:cNvPr>
              <p:cNvSpPr txBox="1"/>
              <p:nvPr/>
            </p:nvSpPr>
            <p:spPr>
              <a:xfrm rot="18614811">
                <a:off x="4783787" y="2199069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xmlns="" id="{6F14ABA8-C9BD-834E-AE78-C3DD0EBE24AC}"/>
                  </a:ext>
                </a:extLst>
              </p:cNvPr>
              <p:cNvSpPr txBox="1"/>
              <p:nvPr/>
            </p:nvSpPr>
            <p:spPr>
              <a:xfrm rot="18614811">
                <a:off x="50460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xmlns="" id="{63870D36-6308-0F4F-A4A8-324EDFF2B2A4}"/>
                  </a:ext>
                </a:extLst>
              </p:cNvPr>
              <p:cNvSpPr txBox="1"/>
              <p:nvPr/>
            </p:nvSpPr>
            <p:spPr>
              <a:xfrm rot="18614811">
                <a:off x="5621987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xmlns="" id="{5DD9111E-4670-F34E-9C1D-A925B3DAE78A}"/>
                  </a:ext>
                </a:extLst>
              </p:cNvPr>
              <p:cNvSpPr txBox="1"/>
              <p:nvPr/>
            </p:nvSpPr>
            <p:spPr>
              <a:xfrm rot="18614811">
                <a:off x="58842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xmlns="" id="{9B42E6CD-7AD9-5F49-8180-5FD9D54FD475}"/>
                  </a:ext>
                </a:extLst>
              </p:cNvPr>
              <p:cNvSpPr txBox="1"/>
              <p:nvPr/>
            </p:nvSpPr>
            <p:spPr>
              <a:xfrm rot="18614811">
                <a:off x="6155387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xmlns="" id="{8EAD22CB-6A67-7140-9633-B5D694DE2DF6}"/>
                  </a:ext>
                </a:extLst>
              </p:cNvPr>
              <p:cNvSpPr txBox="1"/>
              <p:nvPr/>
            </p:nvSpPr>
            <p:spPr>
              <a:xfrm rot="18614811">
                <a:off x="6460187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xmlns="" id="{ADF4CC41-FA0B-154C-B514-D453A8CEFE34}"/>
                  </a:ext>
                </a:extLst>
              </p:cNvPr>
              <p:cNvSpPr txBox="1"/>
              <p:nvPr/>
            </p:nvSpPr>
            <p:spPr>
              <a:xfrm rot="18614811">
                <a:off x="67224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xmlns="" id="{C4E78F33-EE78-0446-A691-FE2137501C5D}"/>
                  </a:ext>
                </a:extLst>
              </p:cNvPr>
              <p:cNvSpPr txBox="1"/>
              <p:nvPr/>
            </p:nvSpPr>
            <p:spPr>
              <a:xfrm rot="18614811">
                <a:off x="7027213" y="2212042"/>
                <a:ext cx="228600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936612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642</TotalTime>
  <Words>148</Words>
  <Application>Microsoft Office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Pon Abirami A.</cp:lastModifiedBy>
  <cp:revision>178</cp:revision>
  <dcterms:created xsi:type="dcterms:W3CDTF">2020-04-03T19:59:23Z</dcterms:created>
  <dcterms:modified xsi:type="dcterms:W3CDTF">2021-04-07T08:07:59Z</dcterms:modified>
</cp:coreProperties>
</file>